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1782" y="-15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FF1323-483B-47A0-AD81-F7E954D38B9F}" type="datetimeFigureOut">
              <a:rPr lang="en-US" smtClean="0"/>
              <a:pPr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5F332-E341-4E5B-ADBD-119B35ADD83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457200" y="5127458"/>
            <a:ext cx="6172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2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Virus detection i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AD-affected apple trees used for high-throughput sequencing. The four viruses are appl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uteoviru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1 (ALV-1), apple chlorotic leaf spot virus (ACLSV), apple stem grooving virus (ASGV) and apple stem pitting virus (ASPV). Lanes M) 1 kb plus DNA ladder, and W) water. Arrow indicate the DNA fragment with</a:t>
            </a:r>
          </a:p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abeled size.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1296643" y="1600200"/>
            <a:ext cx="4189757" cy="2748380"/>
            <a:chOff x="580564" y="3804821"/>
            <a:chExt cx="4189757" cy="2748380"/>
          </a:xfrm>
        </p:grpSpPr>
        <p:grpSp>
          <p:nvGrpSpPr>
            <p:cNvPr id="24" name="Group 1"/>
            <p:cNvGrpSpPr/>
            <p:nvPr/>
          </p:nvGrpSpPr>
          <p:grpSpPr>
            <a:xfrm>
              <a:off x="580564" y="3804821"/>
              <a:ext cx="4189757" cy="2748380"/>
              <a:chOff x="580564" y="3804821"/>
              <a:chExt cx="4189757" cy="2748380"/>
            </a:xfrm>
          </p:grpSpPr>
          <p:grpSp>
            <p:nvGrpSpPr>
              <p:cNvPr id="35" name="Group 3"/>
              <p:cNvGrpSpPr/>
              <p:nvPr/>
            </p:nvGrpSpPr>
            <p:grpSpPr>
              <a:xfrm>
                <a:off x="580564" y="4218056"/>
                <a:ext cx="4189757" cy="2335145"/>
                <a:chOff x="1218739" y="2168723"/>
                <a:chExt cx="4189757" cy="2517577"/>
              </a:xfrm>
            </p:grpSpPr>
            <p:pic>
              <p:nvPicPr>
                <p:cNvPr id="37" name="Picture 3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1905000" y="4000500"/>
                  <a:ext cx="2743200" cy="6858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8" name="Picture 4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1912951" y="3328823"/>
                  <a:ext cx="2743200" cy="66215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39" name="TextBox 38"/>
                <p:cNvSpPr txBox="1"/>
                <p:nvPr/>
              </p:nvSpPr>
              <p:spPr>
                <a:xfrm>
                  <a:off x="4640557" y="2218497"/>
                  <a:ext cx="669479" cy="3318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ALV-1</a:t>
                  </a: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4635527" y="2819400"/>
                  <a:ext cx="772969" cy="3318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ACLSV</a:t>
                  </a: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4629150" y="3457575"/>
                  <a:ext cx="673582" cy="3318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ASGV</a:t>
                  </a: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4619625" y="4114800"/>
                  <a:ext cx="643125" cy="3318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ASPV</a:t>
                  </a:r>
                </a:p>
              </p:txBody>
            </p:sp>
            <p:cxnSp>
              <p:nvCxnSpPr>
                <p:cNvPr id="43" name="Straight Arrow Connector 42"/>
                <p:cNvCxnSpPr/>
                <p:nvPr/>
              </p:nvCxnSpPr>
              <p:spPr>
                <a:xfrm>
                  <a:off x="1837668" y="2343150"/>
                  <a:ext cx="76200" cy="0"/>
                </a:xfrm>
                <a:prstGeom prst="straightConnector1">
                  <a:avLst/>
                </a:prstGeom>
                <a:ln w="28575">
                  <a:headEnd type="none" w="med" len="med"/>
                  <a:tailEnd type="triangl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Arrow Connector 43"/>
                <p:cNvCxnSpPr/>
                <p:nvPr/>
              </p:nvCxnSpPr>
              <p:spPr>
                <a:xfrm>
                  <a:off x="1828800" y="3039814"/>
                  <a:ext cx="76200" cy="0"/>
                </a:xfrm>
                <a:prstGeom prst="straightConnector1">
                  <a:avLst/>
                </a:prstGeom>
                <a:ln w="28575">
                  <a:headEnd type="none" w="med" len="med"/>
                  <a:tailEnd type="triangl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Arrow Connector 44"/>
                <p:cNvCxnSpPr/>
                <p:nvPr/>
              </p:nvCxnSpPr>
              <p:spPr>
                <a:xfrm>
                  <a:off x="1827607" y="3574470"/>
                  <a:ext cx="76200" cy="0"/>
                </a:xfrm>
                <a:prstGeom prst="straightConnector1">
                  <a:avLst/>
                </a:prstGeom>
                <a:ln w="28575">
                  <a:headEnd type="none" w="med" len="med"/>
                  <a:tailEnd type="triangl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Arrow Connector 45"/>
                <p:cNvCxnSpPr/>
                <p:nvPr/>
              </p:nvCxnSpPr>
              <p:spPr>
                <a:xfrm>
                  <a:off x="1828800" y="4238625"/>
                  <a:ext cx="76200" cy="0"/>
                </a:xfrm>
                <a:prstGeom prst="straightConnector1">
                  <a:avLst/>
                </a:prstGeom>
                <a:ln w="28575">
                  <a:headEnd type="none" w="med" len="med"/>
                  <a:tailEnd type="triangle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7" name="TextBox 46"/>
                <p:cNvSpPr txBox="1"/>
                <p:nvPr/>
              </p:nvSpPr>
              <p:spPr>
                <a:xfrm>
                  <a:off x="1225366" y="2168723"/>
                  <a:ext cx="607859" cy="2986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itchFamily="18" charset="0"/>
                      <a:cs typeface="Times New Roman" pitchFamily="18" charset="0"/>
                    </a:rPr>
                    <a:t>500 </a:t>
                  </a:r>
                  <a:r>
                    <a:rPr lang="en-US" sz="1200" dirty="0" err="1">
                      <a:latin typeface="Times New Roman" pitchFamily="18" charset="0"/>
                      <a:cs typeface="Times New Roman" pitchFamily="18" charset="0"/>
                    </a:rPr>
                    <a:t>bp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1371600" y="2868959"/>
                  <a:ext cx="453970" cy="2986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itchFamily="18" charset="0"/>
                      <a:cs typeface="Times New Roman" pitchFamily="18" charset="0"/>
                    </a:rPr>
                    <a:t>1 kb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1218739" y="3391048"/>
                  <a:ext cx="607859" cy="2986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itchFamily="18" charset="0"/>
                      <a:cs typeface="Times New Roman" pitchFamily="18" charset="0"/>
                    </a:rPr>
                    <a:t>850 </a:t>
                  </a:r>
                  <a:r>
                    <a:rPr lang="en-US" sz="1200" dirty="0" err="1">
                      <a:latin typeface="Times New Roman" pitchFamily="18" charset="0"/>
                      <a:cs typeface="Times New Roman" pitchFamily="18" charset="0"/>
                    </a:rPr>
                    <a:t>bp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1229618" y="4071355"/>
                  <a:ext cx="607859" cy="2986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itchFamily="18" charset="0"/>
                      <a:cs typeface="Times New Roman" pitchFamily="18" charset="0"/>
                    </a:rPr>
                    <a:t>500 </a:t>
                  </a:r>
                  <a:r>
                    <a:rPr lang="en-US" sz="1200" dirty="0" err="1">
                      <a:latin typeface="Times New Roman" pitchFamily="18" charset="0"/>
                      <a:cs typeface="Times New Roman" pitchFamily="18" charset="0"/>
                    </a:rPr>
                    <a:t>bp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36" name="TextBox 35"/>
              <p:cNvSpPr txBox="1"/>
              <p:nvPr/>
            </p:nvSpPr>
            <p:spPr>
              <a:xfrm>
                <a:off x="1258091" y="3804821"/>
                <a:ext cx="27839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  PA2   PA4   PA5  PA7  PA8   PA9   W</a:t>
                </a:r>
              </a:p>
            </p:txBody>
          </p:sp>
        </p:grpSp>
        <p:pic>
          <p:nvPicPr>
            <p:cNvPr id="25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283970" y="4038599"/>
              <a:ext cx="2743200" cy="6268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6" name="Group 25"/>
            <p:cNvGrpSpPr/>
            <p:nvPr/>
          </p:nvGrpSpPr>
          <p:grpSpPr>
            <a:xfrm>
              <a:off x="1275207" y="4676775"/>
              <a:ext cx="2743200" cy="609599"/>
              <a:chOff x="1752600" y="2743200"/>
              <a:chExt cx="4876800" cy="1152525"/>
            </a:xfrm>
          </p:grpSpPr>
          <p:pic>
            <p:nvPicPr>
              <p:cNvPr id="27" name="Picture 9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752600" y="2743200"/>
                <a:ext cx="3114675" cy="11525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" name="Picture 1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858560" y="2743200"/>
                <a:ext cx="1770840" cy="11525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90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uhui.Li</dc:creator>
  <cp:lastModifiedBy>Li, Ruhui</cp:lastModifiedBy>
  <cp:revision>29</cp:revision>
  <dcterms:created xsi:type="dcterms:W3CDTF">2017-05-11T15:08:07Z</dcterms:created>
  <dcterms:modified xsi:type="dcterms:W3CDTF">2018-04-06T15:14:24Z</dcterms:modified>
</cp:coreProperties>
</file>